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00"/>
    <p:restoredTop sz="95775"/>
  </p:normalViewPr>
  <p:slideViewPr>
    <p:cSldViewPr snapToGrid="0">
      <p:cViewPr varScale="1">
        <p:scale>
          <a:sx n="105" d="100"/>
          <a:sy n="105" d="100"/>
        </p:scale>
        <p:origin x="216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B1ACC-DE8B-0739-211A-C3D3231BD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FD042F-C329-041B-9642-95D2288FA8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FF71B1-73E9-36C7-ED74-22CE19C45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296087-D35F-35A1-07A2-329C0C24A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A04A4-CFF0-DD6A-1799-F3F73CAF3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576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4CBA2-1705-FEEB-FBCB-1DA4C12BCA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17624C-EB8C-36B1-84EF-76195F91AE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398AE-8B36-E94D-A09E-283F9F939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51FB3-36F4-8E17-7052-B85E0E4C4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FC3F4-48A6-52D8-0F65-9224AC8E5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30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82355A-558D-2AD4-91C0-251189D0A7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8FB933-EB92-74F8-473F-CD6A11319B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734614-A49E-CEA4-1B78-BBD341A66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D85AFA-5962-AE65-5A48-A349CD0D6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0DBBFE-4044-0B57-F50C-0CFA1264B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ED9802-1B76-C42F-5BA9-C03F8983C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A561F7-8220-E629-465D-1886FDA581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4AA5AA-051F-FC23-0B8F-FB8044D03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0A8986-67B3-9E18-F91B-3E7A78775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BFB3BC-2BC7-A394-C47A-26C17F17E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616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43175-ADD4-3037-C364-F93D634D3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712330-BF56-30C0-B288-EB9319C43C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B144C6-2D7D-8131-14E1-DEBF74EAB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D5597D-934E-3BCE-243E-636B8A31A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724B32-EED2-A482-8D1C-EA1775FDF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9482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31017-004B-7D09-6A62-93EFE4AE1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43080B-0543-F233-50E8-F6929CA0EE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AC6529-A8B2-2013-A7E1-2FE120B241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69C8DF-9FF6-66ED-DCCD-0B8845233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C0A278-37DD-8A14-9139-8DED5DE82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83338-B9BC-B3DB-C8EA-97A542458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680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F508B1-9EBC-99DF-2B2B-984C45486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A4EE8B-BBA3-099A-ECAD-8513E32DE0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170DF8-5ED1-0D53-6428-0206155420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F61FD9-A5A6-7319-2CA6-47FF4E5916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317C09-4418-32B4-01F3-82A5753C05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F5CA2F-C435-487F-D019-06311D02F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78CBCB-7C95-98F2-9EEF-445017E97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CD28CE-8207-64C3-3826-604604E14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036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A8D643-CDC5-021A-6E99-7CADEDCFD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73DFEA-B0A9-5BE5-F707-D148051BD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4973D2-DE72-E900-F644-B8DFA926A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8F55D0-F075-DD1D-19CA-7737A170E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751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CFBB11-D66C-F482-F299-8A9554878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C7FCAE-DC04-36D6-AFEC-04EC721DE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9D8F50-4D21-3080-857E-1D764806A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433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16C29-8B32-5B5C-6077-3271D864A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CAD38E-CAB9-C965-8990-3F8F78C0A8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FF32C5-A012-5B38-0B55-06FFF7E251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658238-AD4E-B6F4-340E-28A8B7762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D7D23F-A1A8-3612-B145-D13B88E26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8EB70E-13AB-FF0F-32FE-9D3B7D349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46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99AFF-F9C4-A508-76C6-6E7138FA1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4AD208-D03C-9E7F-060A-017ECB24B8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481534-4B52-FBBA-29D0-552F06B2ED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F39CB0-8A0E-4769-E2FC-F48634E26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33DBE1-89C1-3B7F-CD70-423529B75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8779F0-DD29-EB79-4512-166EC5BD0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687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8C0097-22E5-FFCB-2C9D-5D45E15EC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9B8238-C705-4A22-ECF2-A0FEC5436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DF043-A9E4-6CD0-864F-C7FDD81AC8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9C198-00CE-994B-84DD-754664BFBA85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DD4913-4280-D1A9-89AB-9497471890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235B11-ADCC-4F33-C789-38634E318A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D8998-757B-A041-983F-4B5C9B2715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8427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830897A-530C-5138-19C1-404BBAFA65C1}"/>
              </a:ext>
            </a:extLst>
          </p:cNvPr>
          <p:cNvGrpSpPr/>
          <p:nvPr/>
        </p:nvGrpSpPr>
        <p:grpSpPr>
          <a:xfrm>
            <a:off x="1358930" y="991430"/>
            <a:ext cx="6995083" cy="3669028"/>
            <a:chOff x="1358930" y="991430"/>
            <a:chExt cx="6995083" cy="366902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8D18657-9DE2-67A4-499C-7E7EAE45656A}"/>
                </a:ext>
              </a:extLst>
            </p:cNvPr>
            <p:cNvGrpSpPr/>
            <p:nvPr/>
          </p:nvGrpSpPr>
          <p:grpSpPr>
            <a:xfrm>
              <a:off x="2649888" y="2028022"/>
              <a:ext cx="2025037" cy="592853"/>
              <a:chOff x="1291288" y="1654018"/>
              <a:chExt cx="2025037" cy="592853"/>
            </a:xfrm>
          </p:grpSpPr>
          <p:pic>
            <p:nvPicPr>
              <p:cNvPr id="39" name="Google Shape;60;p14">
                <a:extLst>
                  <a:ext uri="{FF2B5EF4-FFF2-40B4-BE49-F238E27FC236}">
                    <a16:creationId xmlns:a16="http://schemas.microsoft.com/office/drawing/2014/main" id="{245393C7-01A8-C0AA-8494-04B196464501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t="44505" r="70501" b="35403"/>
              <a:stretch/>
            </p:blipFill>
            <p:spPr>
              <a:xfrm>
                <a:off x="1291288" y="1654018"/>
                <a:ext cx="1500337" cy="592853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0" name="Google Shape;60;p14">
                <a:extLst>
                  <a:ext uri="{FF2B5EF4-FFF2-40B4-BE49-F238E27FC236}">
                    <a16:creationId xmlns:a16="http://schemas.microsoft.com/office/drawing/2014/main" id="{E269B811-7C3F-E95E-AAA4-70ABE03D9FCD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l="80606" t="44505" r="9047" b="35403"/>
              <a:stretch/>
            </p:blipFill>
            <p:spPr>
              <a:xfrm>
                <a:off x="2790091" y="1654018"/>
                <a:ext cx="526234" cy="592853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graphicFrame>
          <p:nvGraphicFramePr>
            <p:cNvPr id="6" name="Google Shape;61;p14">
              <a:extLst>
                <a:ext uri="{FF2B5EF4-FFF2-40B4-BE49-F238E27FC236}">
                  <a16:creationId xmlns:a16="http://schemas.microsoft.com/office/drawing/2014/main" id="{3C37A689-EFF1-62F5-74CA-F09AC9DE706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180788744"/>
                </p:ext>
              </p:extLst>
            </p:nvPr>
          </p:nvGraphicFramePr>
          <p:xfrm>
            <a:off x="2640538" y="1584424"/>
            <a:ext cx="2041868" cy="1050008"/>
          </p:xfrm>
          <a:graphic>
            <a:graphicData uri="http://schemas.openxmlformats.org/drawingml/2006/table">
              <a:tbl>
                <a:tblPr>
                  <a:noFill/>
                </a:tblPr>
                <a:tblGrid>
                  <a:gridCol w="510467">
                    <a:extLst>
                      <a:ext uri="{9D8B030D-6E8A-4147-A177-3AD203B41FA5}">
                        <a16:colId xmlns:a16="http://schemas.microsoft.com/office/drawing/2014/main" val="20000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1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2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3"/>
                      </a:ext>
                    </a:extLst>
                  </a:gridCol>
                </a:tblGrid>
                <a:tr h="350518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UT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L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 dirty="0"/>
                          <a:t>D1</a:t>
                        </a:r>
                        <a:endParaRPr sz="12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-SG" sz="1200" dirty="0"/>
                          <a:t>Ctrl</a:t>
                        </a:r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0"/>
                    </a:ext>
                  </a:extLst>
                </a:tr>
                <a:tr h="623328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lang="en-SG"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1"/>
                    </a:ext>
                  </a:extLst>
                </a:tr>
              </a:tbl>
            </a:graphicData>
          </a:graphic>
        </p:graphicFrame>
        <p:cxnSp>
          <p:nvCxnSpPr>
            <p:cNvPr id="7" name="Google Shape;70;p14">
              <a:extLst>
                <a:ext uri="{FF2B5EF4-FFF2-40B4-BE49-F238E27FC236}">
                  <a16:creationId xmlns:a16="http://schemas.microsoft.com/office/drawing/2014/main" id="{C6959455-E94F-9310-F7AD-71E860D120FF}"/>
                </a:ext>
              </a:extLst>
            </p:cNvPr>
            <p:cNvCxnSpPr/>
            <p:nvPr/>
          </p:nvCxnSpPr>
          <p:spPr>
            <a:xfrm rot="10800000">
              <a:off x="2394154" y="2352555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8" name="Google Shape;71;p14">
              <a:extLst>
                <a:ext uri="{FF2B5EF4-FFF2-40B4-BE49-F238E27FC236}">
                  <a16:creationId xmlns:a16="http://schemas.microsoft.com/office/drawing/2014/main" id="{05D7326E-1234-B0B7-681C-DB4F00966618}"/>
                </a:ext>
              </a:extLst>
            </p:cNvPr>
            <p:cNvSpPr txBox="1"/>
            <p:nvPr/>
          </p:nvSpPr>
          <p:spPr>
            <a:xfrm>
              <a:off x="1682087" y="2144355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0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9" name="Google Shape;72;p14">
              <a:extLst>
                <a:ext uri="{FF2B5EF4-FFF2-40B4-BE49-F238E27FC236}">
                  <a16:creationId xmlns:a16="http://schemas.microsoft.com/office/drawing/2014/main" id="{32F36885-5E87-4F7E-7F02-9DE9D31FEDA8}"/>
                </a:ext>
              </a:extLst>
            </p:cNvPr>
            <p:cNvCxnSpPr/>
            <p:nvPr/>
          </p:nvCxnSpPr>
          <p:spPr>
            <a:xfrm rot="10800000">
              <a:off x="2368687" y="2086366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0" name="Google Shape;73;p14">
              <a:extLst>
                <a:ext uri="{FF2B5EF4-FFF2-40B4-BE49-F238E27FC236}">
                  <a16:creationId xmlns:a16="http://schemas.microsoft.com/office/drawing/2014/main" id="{A5A0DC16-1887-486F-4450-87CDD7322A6C}"/>
                </a:ext>
              </a:extLst>
            </p:cNvPr>
            <p:cNvSpPr txBox="1"/>
            <p:nvPr/>
          </p:nvSpPr>
          <p:spPr>
            <a:xfrm>
              <a:off x="1656620" y="1878166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5  kDa</a:t>
              </a:r>
              <a:endParaRPr sz="1200">
                <a:latin typeface="Helvetica" pitchFamily="2" charset="0"/>
              </a:endParaRPr>
            </a:p>
          </p:txBody>
        </p:sp>
        <p:sp>
          <p:nvSpPr>
            <p:cNvPr id="11" name="Google Shape;74;p14">
              <a:extLst>
                <a:ext uri="{FF2B5EF4-FFF2-40B4-BE49-F238E27FC236}">
                  <a16:creationId xmlns:a16="http://schemas.microsoft.com/office/drawing/2014/main" id="{BA786867-4AE2-86A0-2685-EED53E46A1BB}"/>
                </a:ext>
              </a:extLst>
            </p:cNvPr>
            <p:cNvSpPr txBox="1"/>
            <p:nvPr/>
          </p:nvSpPr>
          <p:spPr>
            <a:xfrm>
              <a:off x="2640538" y="1076210"/>
              <a:ext cx="2034387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-SG" sz="1400" u="sng" dirty="0">
                  <a:latin typeface="Helvetica" pitchFamily="2" charset="0"/>
                </a:rPr>
                <a:t>C</a:t>
              </a:r>
              <a:r>
                <a:rPr lang="en" sz="1400" u="sng" dirty="0">
                  <a:latin typeface="Helvetica" pitchFamily="2" charset="0"/>
                </a:rPr>
                <a:t>ell lysate</a:t>
              </a:r>
              <a:endParaRPr sz="1400" u="sng" dirty="0">
                <a:latin typeface="Helvetica" pitchFamily="2" charset="0"/>
              </a:endParaRPr>
            </a:p>
          </p:txBody>
        </p:sp>
        <p:pic>
          <p:nvPicPr>
            <p:cNvPr id="12" name="Google Shape;83;p15">
              <a:extLst>
                <a:ext uri="{FF2B5EF4-FFF2-40B4-BE49-F238E27FC236}">
                  <a16:creationId xmlns:a16="http://schemas.microsoft.com/office/drawing/2014/main" id="{34BD73D5-883B-34A0-07E5-AFC48045883E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3172" t="28495" r="67759" b="41499"/>
            <a:stretch/>
          </p:blipFill>
          <p:spPr>
            <a:xfrm>
              <a:off x="6322722" y="3088354"/>
              <a:ext cx="1515542" cy="82316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Google Shape;84;p15">
              <a:extLst>
                <a:ext uri="{FF2B5EF4-FFF2-40B4-BE49-F238E27FC236}">
                  <a16:creationId xmlns:a16="http://schemas.microsoft.com/office/drawing/2014/main" id="{F2F4096A-D9C5-3D6A-82A1-79C0E610FE1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2105" r="68636" b="77663"/>
            <a:stretch/>
          </p:blipFill>
          <p:spPr>
            <a:xfrm>
              <a:off x="6312825" y="2063254"/>
              <a:ext cx="1525438" cy="62587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Google Shape;90;p15">
              <a:extLst>
                <a:ext uri="{FF2B5EF4-FFF2-40B4-BE49-F238E27FC236}">
                  <a16:creationId xmlns:a16="http://schemas.microsoft.com/office/drawing/2014/main" id="{BCD461A9-86CE-347B-FD03-69F7C02FAD94}"/>
                </a:ext>
              </a:extLst>
            </p:cNvPr>
            <p:cNvSpPr txBox="1"/>
            <p:nvPr/>
          </p:nvSpPr>
          <p:spPr>
            <a:xfrm>
              <a:off x="6312145" y="1080819"/>
              <a:ext cx="2041868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400" u="sng" dirty="0">
                  <a:latin typeface="Helvetica" pitchFamily="2" charset="0"/>
                </a:rPr>
                <a:t>Cell lysate</a:t>
              </a:r>
              <a:endParaRPr sz="1400" u="sng" dirty="0">
                <a:latin typeface="Helvetica" pitchFamily="2" charset="0"/>
              </a:endParaRPr>
            </a:p>
          </p:txBody>
        </p:sp>
        <p:cxnSp>
          <p:nvCxnSpPr>
            <p:cNvPr id="15" name="Google Shape;91;p15">
              <a:extLst>
                <a:ext uri="{FF2B5EF4-FFF2-40B4-BE49-F238E27FC236}">
                  <a16:creationId xmlns:a16="http://schemas.microsoft.com/office/drawing/2014/main" id="{5B61A15E-71CD-B246-622E-E84CB6FB1441}"/>
                </a:ext>
              </a:extLst>
            </p:cNvPr>
            <p:cNvCxnSpPr/>
            <p:nvPr/>
          </p:nvCxnSpPr>
          <p:spPr>
            <a:xfrm rot="10800000">
              <a:off x="6012405" y="3730635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6" name="Google Shape;92;p15">
              <a:extLst>
                <a:ext uri="{FF2B5EF4-FFF2-40B4-BE49-F238E27FC236}">
                  <a16:creationId xmlns:a16="http://schemas.microsoft.com/office/drawing/2014/main" id="{23882486-3F3B-9A64-9401-5EF6EEE69218}"/>
                </a:ext>
              </a:extLst>
            </p:cNvPr>
            <p:cNvSpPr txBox="1"/>
            <p:nvPr/>
          </p:nvSpPr>
          <p:spPr>
            <a:xfrm>
              <a:off x="5300339" y="3522435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0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17" name="Google Shape;93;p15">
              <a:extLst>
                <a:ext uri="{FF2B5EF4-FFF2-40B4-BE49-F238E27FC236}">
                  <a16:creationId xmlns:a16="http://schemas.microsoft.com/office/drawing/2014/main" id="{9E18816F-CDC8-6264-7007-FC718F243D7A}"/>
                </a:ext>
              </a:extLst>
            </p:cNvPr>
            <p:cNvCxnSpPr/>
            <p:nvPr/>
          </p:nvCxnSpPr>
          <p:spPr>
            <a:xfrm rot="10800000">
              <a:off x="5986939" y="3464445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18" name="Google Shape;94;p15">
              <a:extLst>
                <a:ext uri="{FF2B5EF4-FFF2-40B4-BE49-F238E27FC236}">
                  <a16:creationId xmlns:a16="http://schemas.microsoft.com/office/drawing/2014/main" id="{A14772D0-3F7B-B19F-DBB9-8E4E37987B33}"/>
                </a:ext>
              </a:extLst>
            </p:cNvPr>
            <p:cNvSpPr txBox="1"/>
            <p:nvPr/>
          </p:nvSpPr>
          <p:spPr>
            <a:xfrm>
              <a:off x="5274872" y="3256245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5 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19" name="Google Shape;95;p15">
              <a:extLst>
                <a:ext uri="{FF2B5EF4-FFF2-40B4-BE49-F238E27FC236}">
                  <a16:creationId xmlns:a16="http://schemas.microsoft.com/office/drawing/2014/main" id="{2023721C-F9B4-6510-6BD1-2EEA54A83D84}"/>
                </a:ext>
              </a:extLst>
            </p:cNvPr>
            <p:cNvCxnSpPr/>
            <p:nvPr/>
          </p:nvCxnSpPr>
          <p:spPr>
            <a:xfrm rot="10800000">
              <a:off x="6116626" y="2507843"/>
              <a:ext cx="991600" cy="12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0" name="Google Shape;96;p15">
              <a:extLst>
                <a:ext uri="{FF2B5EF4-FFF2-40B4-BE49-F238E27FC236}">
                  <a16:creationId xmlns:a16="http://schemas.microsoft.com/office/drawing/2014/main" id="{517E7011-1844-F2A4-C06B-686E53D4309A}"/>
                </a:ext>
              </a:extLst>
            </p:cNvPr>
            <p:cNvSpPr txBox="1"/>
            <p:nvPr/>
          </p:nvSpPr>
          <p:spPr>
            <a:xfrm>
              <a:off x="5468472" y="2321001"/>
              <a:ext cx="7540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50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21" name="Google Shape;97;p15">
              <a:extLst>
                <a:ext uri="{FF2B5EF4-FFF2-40B4-BE49-F238E27FC236}">
                  <a16:creationId xmlns:a16="http://schemas.microsoft.com/office/drawing/2014/main" id="{33666CE1-9D8F-C93B-D2FF-BB675123694D}"/>
                </a:ext>
              </a:extLst>
            </p:cNvPr>
            <p:cNvCxnSpPr/>
            <p:nvPr/>
          </p:nvCxnSpPr>
          <p:spPr>
            <a:xfrm rot="10800000">
              <a:off x="6093448" y="2269109"/>
              <a:ext cx="991600" cy="12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2" name="Google Shape;98;p15">
              <a:extLst>
                <a:ext uri="{FF2B5EF4-FFF2-40B4-BE49-F238E27FC236}">
                  <a16:creationId xmlns:a16="http://schemas.microsoft.com/office/drawing/2014/main" id="{E434957A-3506-EBCC-83A2-6DB054CCD3F8}"/>
                </a:ext>
              </a:extLst>
            </p:cNvPr>
            <p:cNvSpPr txBox="1"/>
            <p:nvPr/>
          </p:nvSpPr>
          <p:spPr>
            <a:xfrm>
              <a:off x="5468460" y="2085257"/>
              <a:ext cx="7540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75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23" name="Google Shape;99;p15">
              <a:extLst>
                <a:ext uri="{FF2B5EF4-FFF2-40B4-BE49-F238E27FC236}">
                  <a16:creationId xmlns:a16="http://schemas.microsoft.com/office/drawing/2014/main" id="{7C320F19-969A-8466-7484-0D85590BFAEF}"/>
                </a:ext>
              </a:extLst>
            </p:cNvPr>
            <p:cNvCxnSpPr/>
            <p:nvPr/>
          </p:nvCxnSpPr>
          <p:spPr>
            <a:xfrm rot="10800000">
              <a:off x="5993160" y="2145952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4" name="Google Shape;100;p15">
              <a:extLst>
                <a:ext uri="{FF2B5EF4-FFF2-40B4-BE49-F238E27FC236}">
                  <a16:creationId xmlns:a16="http://schemas.microsoft.com/office/drawing/2014/main" id="{2E4EF29A-090A-6740-2F15-19CAA46F61E7}"/>
                </a:ext>
              </a:extLst>
            </p:cNvPr>
            <p:cNvSpPr txBox="1"/>
            <p:nvPr/>
          </p:nvSpPr>
          <p:spPr>
            <a:xfrm>
              <a:off x="5281093" y="1937752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100 kDa</a:t>
              </a:r>
              <a:endParaRPr sz="1200">
                <a:latin typeface="Helvetica" pitchFamily="2" charset="0"/>
              </a:endParaRPr>
            </a:p>
          </p:txBody>
        </p:sp>
        <p:pic>
          <p:nvPicPr>
            <p:cNvPr id="25" name="Google Shape;124;p16">
              <a:extLst>
                <a:ext uri="{FF2B5EF4-FFF2-40B4-BE49-F238E27FC236}">
                  <a16:creationId xmlns:a16="http://schemas.microsoft.com/office/drawing/2014/main" id="{931027AA-0C76-98A9-BB6E-B2085A30270D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l="4214" t="48186" r="67290" b="28203"/>
            <a:stretch/>
          </p:blipFill>
          <p:spPr>
            <a:xfrm>
              <a:off x="2650951" y="3874765"/>
              <a:ext cx="1518584" cy="76273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6" name="Google Shape;128;p16">
              <a:extLst>
                <a:ext uri="{FF2B5EF4-FFF2-40B4-BE49-F238E27FC236}">
                  <a16:creationId xmlns:a16="http://schemas.microsoft.com/office/drawing/2014/main" id="{B77E9A05-8465-B77C-2142-B43648D7212B}"/>
                </a:ext>
              </a:extLst>
            </p:cNvPr>
            <p:cNvSpPr txBox="1"/>
            <p:nvPr/>
          </p:nvSpPr>
          <p:spPr>
            <a:xfrm>
              <a:off x="2636893" y="2952391"/>
              <a:ext cx="2041868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400" u="sng" dirty="0">
                  <a:latin typeface="Helvetica" pitchFamily="2" charset="0"/>
                </a:rPr>
                <a:t>Conditioned medium</a:t>
              </a:r>
              <a:endParaRPr sz="1400" u="sng" dirty="0">
                <a:latin typeface="Helvetica" pitchFamily="2" charset="0"/>
              </a:endParaRPr>
            </a:p>
          </p:txBody>
        </p:sp>
        <p:cxnSp>
          <p:nvCxnSpPr>
            <p:cNvPr id="27" name="Google Shape;129;p16">
              <a:extLst>
                <a:ext uri="{FF2B5EF4-FFF2-40B4-BE49-F238E27FC236}">
                  <a16:creationId xmlns:a16="http://schemas.microsoft.com/office/drawing/2014/main" id="{0FBBB2AA-5D9E-DB7D-50D3-C86033FEBB4E}"/>
                </a:ext>
              </a:extLst>
            </p:cNvPr>
            <p:cNvCxnSpPr/>
            <p:nvPr/>
          </p:nvCxnSpPr>
          <p:spPr>
            <a:xfrm rot="10800000">
              <a:off x="2372818" y="4456378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8" name="Google Shape;130;p16">
              <a:extLst>
                <a:ext uri="{FF2B5EF4-FFF2-40B4-BE49-F238E27FC236}">
                  <a16:creationId xmlns:a16="http://schemas.microsoft.com/office/drawing/2014/main" id="{812D4F06-B7CB-9CE5-641B-010A0922A9AA}"/>
                </a:ext>
              </a:extLst>
            </p:cNvPr>
            <p:cNvSpPr txBox="1"/>
            <p:nvPr/>
          </p:nvSpPr>
          <p:spPr>
            <a:xfrm>
              <a:off x="1812266" y="4229611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0 kDa</a:t>
              </a:r>
              <a:endParaRPr sz="1200">
                <a:latin typeface="Helvetica" pitchFamily="2" charset="0"/>
              </a:endParaRPr>
            </a:p>
          </p:txBody>
        </p:sp>
        <p:cxnSp>
          <p:nvCxnSpPr>
            <p:cNvPr id="29" name="Google Shape;131;p16">
              <a:extLst>
                <a:ext uri="{FF2B5EF4-FFF2-40B4-BE49-F238E27FC236}">
                  <a16:creationId xmlns:a16="http://schemas.microsoft.com/office/drawing/2014/main" id="{184F7A85-2FBE-A3D7-02FE-7201B91061B7}"/>
                </a:ext>
              </a:extLst>
            </p:cNvPr>
            <p:cNvCxnSpPr/>
            <p:nvPr/>
          </p:nvCxnSpPr>
          <p:spPr>
            <a:xfrm rot="10800000">
              <a:off x="2367317" y="4038675"/>
              <a:ext cx="1089600" cy="144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30" name="Google Shape;132;p16">
              <a:extLst>
                <a:ext uri="{FF2B5EF4-FFF2-40B4-BE49-F238E27FC236}">
                  <a16:creationId xmlns:a16="http://schemas.microsoft.com/office/drawing/2014/main" id="{0ECCB7DA-45AF-0018-86C2-EE0BE6184CAC}"/>
                </a:ext>
              </a:extLst>
            </p:cNvPr>
            <p:cNvSpPr txBox="1"/>
            <p:nvPr/>
          </p:nvSpPr>
          <p:spPr>
            <a:xfrm>
              <a:off x="1736885" y="3808735"/>
              <a:ext cx="828400" cy="43084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" sz="1200">
                  <a:latin typeface="Helvetica" pitchFamily="2" charset="0"/>
                </a:rPr>
                <a:t>25  kDa</a:t>
              </a:r>
              <a:endParaRPr sz="1200">
                <a:latin typeface="Helvetica" pitchFamily="2" charset="0"/>
              </a:endParaRPr>
            </a:p>
          </p:txBody>
        </p:sp>
        <p:pic>
          <p:nvPicPr>
            <p:cNvPr id="31" name="Google Shape;124;p16">
              <a:extLst>
                <a:ext uri="{FF2B5EF4-FFF2-40B4-BE49-F238E27FC236}">
                  <a16:creationId xmlns:a16="http://schemas.microsoft.com/office/drawing/2014/main" id="{5EAE44A7-7E84-61DF-ABB1-63B71E5CA551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l="81394" t="48186" r="9294" b="28203"/>
            <a:stretch/>
          </p:blipFill>
          <p:spPr>
            <a:xfrm>
              <a:off x="4170378" y="3874751"/>
              <a:ext cx="496258" cy="762733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32" name="Google Shape;125;p16">
              <a:extLst>
                <a:ext uri="{FF2B5EF4-FFF2-40B4-BE49-F238E27FC236}">
                  <a16:creationId xmlns:a16="http://schemas.microsoft.com/office/drawing/2014/main" id="{F748AE98-380B-13A5-DB1C-F8421892CB89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911753998"/>
                </p:ext>
              </p:extLst>
            </p:nvPr>
          </p:nvGraphicFramePr>
          <p:xfrm>
            <a:off x="2639168" y="3452065"/>
            <a:ext cx="2041868" cy="1185447"/>
          </p:xfrm>
          <a:graphic>
            <a:graphicData uri="http://schemas.openxmlformats.org/drawingml/2006/table">
              <a:tbl>
                <a:tblPr>
                  <a:noFill/>
                </a:tblPr>
                <a:tblGrid>
                  <a:gridCol w="510467">
                    <a:extLst>
                      <a:ext uri="{9D8B030D-6E8A-4147-A177-3AD203B41FA5}">
                        <a16:colId xmlns:a16="http://schemas.microsoft.com/office/drawing/2014/main" val="20000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1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2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3"/>
                      </a:ext>
                    </a:extLst>
                  </a:gridCol>
                </a:tblGrid>
                <a:tr h="426680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UT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L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D1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 dirty="0"/>
                          <a:t>Ctrl</a:t>
                        </a:r>
                        <a:endParaRPr sz="12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0"/>
                    </a:ext>
                  </a:extLst>
                </a:tr>
                <a:tr h="758767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1"/>
                    </a:ext>
                  </a:extLst>
                </a:tr>
              </a:tbl>
            </a:graphicData>
          </a:graphic>
        </p:graphicFrame>
        <p:pic>
          <p:nvPicPr>
            <p:cNvPr id="33" name="Google Shape;83;p15">
              <a:extLst>
                <a:ext uri="{FF2B5EF4-FFF2-40B4-BE49-F238E27FC236}">
                  <a16:creationId xmlns:a16="http://schemas.microsoft.com/office/drawing/2014/main" id="{DB293742-A8E3-7E8C-42AA-CEF8BD5EC53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80543" t="28495" r="9738" b="41499"/>
            <a:stretch/>
          </p:blipFill>
          <p:spPr>
            <a:xfrm>
              <a:off x="7838263" y="3095551"/>
              <a:ext cx="506725" cy="82316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4" name="Google Shape;83;p15">
              <a:extLst>
                <a:ext uri="{FF2B5EF4-FFF2-40B4-BE49-F238E27FC236}">
                  <a16:creationId xmlns:a16="http://schemas.microsoft.com/office/drawing/2014/main" id="{124B4159-E451-51D9-B18D-19D3AB4ED1BA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80543" t="262" r="9738" b="76924"/>
            <a:stretch/>
          </p:blipFill>
          <p:spPr>
            <a:xfrm>
              <a:off x="7838263" y="2058408"/>
              <a:ext cx="506725" cy="625872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35" name="Google Shape;85;p15">
              <a:extLst>
                <a:ext uri="{FF2B5EF4-FFF2-40B4-BE49-F238E27FC236}">
                  <a16:creationId xmlns:a16="http://schemas.microsoft.com/office/drawing/2014/main" id="{A33DB6B5-D49B-6B26-2EDC-009116DE0668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982978898"/>
                </p:ext>
              </p:extLst>
            </p:nvPr>
          </p:nvGraphicFramePr>
          <p:xfrm>
            <a:off x="6303475" y="1596821"/>
            <a:ext cx="2041868" cy="2319847"/>
          </p:xfrm>
          <a:graphic>
            <a:graphicData uri="http://schemas.openxmlformats.org/drawingml/2006/table">
              <a:tbl>
                <a:tblPr>
                  <a:noFill/>
                </a:tblPr>
                <a:tblGrid>
                  <a:gridCol w="510467">
                    <a:extLst>
                      <a:ext uri="{9D8B030D-6E8A-4147-A177-3AD203B41FA5}">
                        <a16:colId xmlns:a16="http://schemas.microsoft.com/office/drawing/2014/main" val="20000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1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2"/>
                      </a:ext>
                    </a:extLst>
                  </a:gridCol>
                  <a:gridCol w="510467">
                    <a:extLst>
                      <a:ext uri="{9D8B030D-6E8A-4147-A177-3AD203B41FA5}">
                        <a16:colId xmlns:a16="http://schemas.microsoft.com/office/drawing/2014/main" val="20003"/>
                      </a:ext>
                    </a:extLst>
                  </a:gridCol>
                </a:tblGrid>
                <a:tr h="460467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 dirty="0"/>
                          <a:t>UT</a:t>
                        </a:r>
                        <a:endParaRPr sz="12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L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/>
                          <a:t>D1</a:t>
                        </a: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r>
                          <a:rPr lang="en" sz="1200" dirty="0"/>
                          <a:t>Ctrl</a:t>
                        </a:r>
                        <a:endParaRPr sz="12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0"/>
                    </a:ext>
                  </a:extLst>
                </a:tr>
                <a:tr h="613867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2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2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1"/>
                    </a:ext>
                  </a:extLst>
                </a:tr>
                <a:tr h="426680">
                  <a:tc gridSpan="4"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1200" b="1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/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/>
                  </a:tc>
                  <a:tc hMerge="1">
                    <a:txBody>
                      <a:bodyPr/>
                      <a:lstStyle/>
                      <a:p>
                        <a:endParaRPr lang="en-US"/>
                      </a:p>
                    </a:txBody>
                    <a:tcPr/>
                  </a:tc>
                  <a:extLst>
                    <a:ext uri="{0D108BD9-81ED-4DB2-BD59-A6C34878D82A}">
                      <a16:rowId xmlns:a16="http://schemas.microsoft.com/office/drawing/2014/main" val="10002"/>
                    </a:ext>
                  </a:extLst>
                </a:tr>
                <a:tr h="818833"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tc>
                    <a:txBody>
                      <a:bodyPr/>
                      <a:lstStyle/>
                      <a:p>
                        <a:pPr marL="0" lvl="0" indent="0" algn="l" rtl="0">
                          <a:spcBef>
                            <a:spcPts val="0"/>
                          </a:spcBef>
                          <a:spcAft>
                            <a:spcPts val="0"/>
                          </a:spcAft>
                          <a:buNone/>
                        </a:pPr>
                        <a:endParaRPr sz="2400" dirty="0"/>
                      </a:p>
                    </a:txBody>
                    <a:tcPr marL="121900" marR="121900" marT="121900" marB="121900">
                      <a:lnL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L>
                      <a:lnR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R>
                      <a:lnT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T>
                      <a:lnB w="9525" cap="flat" cmpd="sng">
                        <a:solidFill>
                          <a:schemeClr val="dk1"/>
                        </a:solidFill>
                        <a:prstDash val="solid"/>
                        <a:round/>
                        <a:headEnd type="none" w="sm" len="sm"/>
                        <a:tailEnd type="none" w="sm" len="sm"/>
                      </a:lnB>
                    </a:tcPr>
                  </a:tc>
                  <a:extLst>
                    <a:ext uri="{0D108BD9-81ED-4DB2-BD59-A6C34878D82A}">
                      <a16:rowId xmlns:a16="http://schemas.microsoft.com/office/drawing/2014/main" val="10003"/>
                    </a:ext>
                  </a:extLst>
                </a:tr>
              </a:tbl>
            </a:graphicData>
          </a:graphic>
        </p:graphicFrame>
        <p:sp>
          <p:nvSpPr>
            <p:cNvPr id="36" name="Google Shape;74;p14">
              <a:extLst>
                <a:ext uri="{FF2B5EF4-FFF2-40B4-BE49-F238E27FC236}">
                  <a16:creationId xmlns:a16="http://schemas.microsoft.com/office/drawing/2014/main" id="{2A0B96AA-B0AF-F1D9-E797-9F3B75F4BD39}"/>
                </a:ext>
              </a:extLst>
            </p:cNvPr>
            <p:cNvSpPr txBox="1"/>
            <p:nvPr/>
          </p:nvSpPr>
          <p:spPr>
            <a:xfrm>
              <a:off x="1358930" y="991430"/>
              <a:ext cx="540840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A)</a:t>
              </a:r>
              <a:endParaRPr sz="1400" b="1" dirty="0">
                <a:latin typeface="Helvetica" pitchFamily="2" charset="0"/>
              </a:endParaRPr>
            </a:p>
          </p:txBody>
        </p:sp>
        <p:sp>
          <p:nvSpPr>
            <p:cNvPr id="37" name="Google Shape;74;p14">
              <a:extLst>
                <a:ext uri="{FF2B5EF4-FFF2-40B4-BE49-F238E27FC236}">
                  <a16:creationId xmlns:a16="http://schemas.microsoft.com/office/drawing/2014/main" id="{F5D675D2-293F-F217-8271-B17A3664D195}"/>
                </a:ext>
              </a:extLst>
            </p:cNvPr>
            <p:cNvSpPr txBox="1"/>
            <p:nvPr/>
          </p:nvSpPr>
          <p:spPr>
            <a:xfrm>
              <a:off x="1364617" y="2857034"/>
              <a:ext cx="540840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B)</a:t>
              </a:r>
              <a:endParaRPr sz="1400" b="1" dirty="0">
                <a:latin typeface="Helvetica" pitchFamily="2" charset="0"/>
              </a:endParaRPr>
            </a:p>
          </p:txBody>
        </p:sp>
        <p:sp>
          <p:nvSpPr>
            <p:cNvPr id="38" name="Google Shape;74;p14">
              <a:extLst>
                <a:ext uri="{FF2B5EF4-FFF2-40B4-BE49-F238E27FC236}">
                  <a16:creationId xmlns:a16="http://schemas.microsoft.com/office/drawing/2014/main" id="{C0323912-C4C1-76F2-39EA-A39C5E9F0E4A}"/>
                </a:ext>
              </a:extLst>
            </p:cNvPr>
            <p:cNvSpPr txBox="1"/>
            <p:nvPr/>
          </p:nvSpPr>
          <p:spPr>
            <a:xfrm>
              <a:off x="5145273" y="996747"/>
              <a:ext cx="540840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C)</a:t>
              </a:r>
              <a:endParaRPr sz="1400" b="1" dirty="0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49666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3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 Jun Yung</dc:creator>
  <cp:lastModifiedBy>Woo Jun Yung</cp:lastModifiedBy>
  <cp:revision>1</cp:revision>
  <dcterms:created xsi:type="dcterms:W3CDTF">2023-11-08T05:36:22Z</dcterms:created>
  <dcterms:modified xsi:type="dcterms:W3CDTF">2023-11-08T05:38:16Z</dcterms:modified>
</cp:coreProperties>
</file>